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71" autoAdjust="0"/>
  </p:normalViewPr>
  <p:slideViewPr>
    <p:cSldViewPr>
      <p:cViewPr>
        <p:scale>
          <a:sx n="120" d="100"/>
          <a:sy n="120" d="100"/>
        </p:scale>
        <p:origin x="-1410" y="-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7374" cy="468474"/>
          </a:xfrm>
          <a:prstGeom prst="rect">
            <a:avLst/>
          </a:prstGeom>
        </p:spPr>
        <p:txBody>
          <a:bodyPr vert="horz" lIns="92181" tIns="46090" rIns="92181" bIns="4609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100" y="0"/>
            <a:ext cx="3067374" cy="468474"/>
          </a:xfrm>
          <a:prstGeom prst="rect">
            <a:avLst/>
          </a:prstGeom>
        </p:spPr>
        <p:txBody>
          <a:bodyPr vert="horz" lIns="92181" tIns="46090" rIns="92181" bIns="46090" rtlCol="0"/>
          <a:lstStyle>
            <a:lvl1pPr algn="r">
              <a:defRPr sz="1200"/>
            </a:lvl1pPr>
          </a:lstStyle>
          <a:p>
            <a:fld id="{6CA27D1C-A1B7-40B9-929D-3B5477A6D9E4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6975" y="701675"/>
            <a:ext cx="4683125" cy="35115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81" tIns="46090" rIns="92181" bIns="4609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8349" y="4448101"/>
            <a:ext cx="5660378" cy="4213064"/>
          </a:xfrm>
          <a:prstGeom prst="rect">
            <a:avLst/>
          </a:prstGeom>
        </p:spPr>
        <p:txBody>
          <a:bodyPr vert="horz" lIns="92181" tIns="46090" rIns="92181" bIns="4609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003"/>
            <a:ext cx="3067374" cy="468474"/>
          </a:xfrm>
          <a:prstGeom prst="rect">
            <a:avLst/>
          </a:prstGeom>
        </p:spPr>
        <p:txBody>
          <a:bodyPr vert="horz" lIns="92181" tIns="46090" rIns="92181" bIns="4609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100" y="8893003"/>
            <a:ext cx="3067374" cy="468474"/>
          </a:xfrm>
          <a:prstGeom prst="rect">
            <a:avLst/>
          </a:prstGeom>
        </p:spPr>
        <p:txBody>
          <a:bodyPr vert="horz" lIns="92181" tIns="46090" rIns="92181" bIns="46090" rtlCol="0" anchor="b"/>
          <a:lstStyle>
            <a:lvl1pPr algn="r">
              <a:defRPr sz="1200"/>
            </a:lvl1pPr>
          </a:lstStyle>
          <a:p>
            <a:fld id="{8C0F8DB2-5EDC-4A39-B6D6-1373811EFD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6327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0F8DB2-5EDC-4A39-B6D6-1373811EFD8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21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682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307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325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96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920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874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611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784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545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941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7E777-8ACC-455F-A915-160488BD2B3B}" type="datetimeFigureOut">
              <a:rPr lang="en-US" smtClean="0"/>
              <a:pPr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E27D0-AAFF-425A-95F7-5E4CF12ACA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697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png"/><Relationship Id="rId4" Type="http://schemas.openxmlformats.org/officeDocument/2006/relationships/image" Target="../media/image2.tif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981200" y="3228201"/>
            <a:ext cx="1295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6553200" y="3200400"/>
            <a:ext cx="1143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TAM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7200" y="104001"/>
            <a:ext cx="2971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1 Fig.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6" name="Group 105"/>
          <p:cNvGrpSpPr/>
          <p:nvPr/>
        </p:nvGrpSpPr>
        <p:grpSpPr>
          <a:xfrm>
            <a:off x="457200" y="3505200"/>
            <a:ext cx="1828800" cy="1371600"/>
            <a:chOff x="2362200" y="3429000"/>
            <a:chExt cx="1828800" cy="1371600"/>
          </a:xfrm>
        </p:grpSpPr>
        <p:pic>
          <p:nvPicPr>
            <p:cNvPr id="2" name="Picture 2" descr="R:\Conneely_Orla\Murugesan\4 Weeks TAM withdraw\Whole Mount May 20 2013\3750 sham 1x_altered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362200" y="3429000"/>
              <a:ext cx="1828800" cy="1371600"/>
            </a:xfrm>
            <a:prstGeom prst="rect">
              <a:avLst/>
            </a:prstGeom>
            <a:noFill/>
          </p:spPr>
        </p:pic>
        <p:sp>
          <p:nvSpPr>
            <p:cNvPr id="26" name="Rectangle 25"/>
            <p:cNvSpPr/>
            <p:nvPr/>
          </p:nvSpPr>
          <p:spPr>
            <a:xfrm flipH="1">
              <a:off x="2438400" y="3733800"/>
              <a:ext cx="381000" cy="304800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   </a:t>
              </a:r>
            </a:p>
          </p:txBody>
        </p:sp>
      </p:grpSp>
      <p:pic>
        <p:nvPicPr>
          <p:cNvPr id="1026" name="Picture 2" descr="R:\Conneely_Orla\Murugesan\P53 null mammary gland project\4 WeeksTAM Withdraw\Whole Mount 1\Whole Mount\Whole Mount May 20 2013\3750 sham 5x altered.ti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362200" y="3505200"/>
            <a:ext cx="1828800" cy="1371600"/>
          </a:xfrm>
          <a:prstGeom prst="rect">
            <a:avLst/>
          </a:prstGeom>
          <a:noFill/>
        </p:spPr>
      </p:pic>
      <p:pic>
        <p:nvPicPr>
          <p:cNvPr id="1027" name="Picture 3" descr="R:\Conneely_Orla\Murugesan\P53 null mammary gland project\4 WeeksTAM Withdraw\Whole Mount 1\Whole Mount\Whole Mount May 20 2013\3751 sham 5x_altered.tif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362200" y="4953000"/>
            <a:ext cx="1828800" cy="1371600"/>
          </a:xfrm>
          <a:prstGeom prst="rect">
            <a:avLst/>
          </a:prstGeom>
          <a:noFill/>
        </p:spPr>
      </p:pic>
      <p:grpSp>
        <p:nvGrpSpPr>
          <p:cNvPr id="107" name="Group 106"/>
          <p:cNvGrpSpPr/>
          <p:nvPr/>
        </p:nvGrpSpPr>
        <p:grpSpPr>
          <a:xfrm>
            <a:off x="457200" y="4953000"/>
            <a:ext cx="1828800" cy="1371600"/>
            <a:chOff x="2362199" y="5181599"/>
            <a:chExt cx="1828800" cy="1371600"/>
          </a:xfrm>
        </p:grpSpPr>
        <p:pic>
          <p:nvPicPr>
            <p:cNvPr id="4" name="Picture 4" descr="R:\Conneely_Orla\Murugesan\4 Weeks TAM withdraw\Whole Mount May 20 2013\3751 sham 1x_altered.tif"/>
            <p:cNvPicPr preferRelativeResize="0"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362199" y="5181599"/>
              <a:ext cx="1828800" cy="1371600"/>
            </a:xfrm>
            <a:prstGeom prst="rect">
              <a:avLst/>
            </a:prstGeom>
            <a:noFill/>
          </p:spPr>
        </p:pic>
        <p:sp>
          <p:nvSpPr>
            <p:cNvPr id="27" name="Rectangle 26"/>
            <p:cNvSpPr/>
            <p:nvPr/>
          </p:nvSpPr>
          <p:spPr>
            <a:xfrm flipH="1">
              <a:off x="2819400" y="5334000"/>
              <a:ext cx="381000" cy="304800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   </a:t>
              </a:r>
            </a:p>
          </p:txBody>
        </p:sp>
      </p:grpSp>
      <p:grpSp>
        <p:nvGrpSpPr>
          <p:cNvPr id="119" name="Group 118"/>
          <p:cNvGrpSpPr/>
          <p:nvPr/>
        </p:nvGrpSpPr>
        <p:grpSpPr>
          <a:xfrm>
            <a:off x="4953000" y="3505200"/>
            <a:ext cx="1828800" cy="1371600"/>
            <a:chOff x="4953000" y="3453491"/>
            <a:chExt cx="1828800" cy="1371600"/>
          </a:xfrm>
        </p:grpSpPr>
        <p:pic>
          <p:nvPicPr>
            <p:cNvPr id="57" name="Picture 2" descr="R:\Conneely_Orla\Murugesan\4 Weeks TAM withdraw\Whole Mount May 20 2013\3762 TAM 1X_altered.tif"/>
            <p:cNvPicPr preferRelativeResize="0"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953000" y="3453491"/>
              <a:ext cx="1828800" cy="1371600"/>
            </a:xfrm>
            <a:prstGeom prst="rect">
              <a:avLst/>
            </a:prstGeom>
            <a:noFill/>
          </p:spPr>
        </p:pic>
        <p:sp>
          <p:nvSpPr>
            <p:cNvPr id="29" name="Rectangle 28"/>
            <p:cNvSpPr/>
            <p:nvPr/>
          </p:nvSpPr>
          <p:spPr>
            <a:xfrm flipH="1">
              <a:off x="5410200" y="4292320"/>
              <a:ext cx="381000" cy="304800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   </a:t>
              </a:r>
            </a:p>
          </p:txBody>
        </p:sp>
      </p:grpSp>
      <p:grpSp>
        <p:nvGrpSpPr>
          <p:cNvPr id="121" name="Group 120"/>
          <p:cNvGrpSpPr/>
          <p:nvPr/>
        </p:nvGrpSpPr>
        <p:grpSpPr>
          <a:xfrm>
            <a:off x="4953000" y="4953000"/>
            <a:ext cx="1828800" cy="1371600"/>
            <a:chOff x="5029200" y="5085691"/>
            <a:chExt cx="1828800" cy="1371600"/>
          </a:xfrm>
        </p:grpSpPr>
        <p:pic>
          <p:nvPicPr>
            <p:cNvPr id="63" name="Picture 4" descr="R:\Conneely_Orla\Murugesan\4 Weeks TAM withdraw\Whole Mount May 20 2013\3763 TAM .1X_altered.tif"/>
            <p:cNvPicPr preferRelativeResize="0"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029200" y="5085691"/>
              <a:ext cx="1828800" cy="1371600"/>
            </a:xfrm>
            <a:prstGeom prst="rect">
              <a:avLst/>
            </a:prstGeom>
            <a:noFill/>
          </p:spPr>
        </p:pic>
        <p:sp>
          <p:nvSpPr>
            <p:cNvPr id="31" name="Rectangle 30"/>
            <p:cNvSpPr/>
            <p:nvPr/>
          </p:nvSpPr>
          <p:spPr>
            <a:xfrm flipH="1">
              <a:off x="5923504" y="5334000"/>
              <a:ext cx="381000" cy="304800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   </a:t>
              </a:r>
            </a:p>
          </p:txBody>
        </p:sp>
      </p:grpSp>
      <p:cxnSp>
        <p:nvCxnSpPr>
          <p:cNvPr id="51" name="Straight Connector 50"/>
          <p:cNvCxnSpPr/>
          <p:nvPr/>
        </p:nvCxnSpPr>
        <p:spPr>
          <a:xfrm flipV="1">
            <a:off x="5791200" y="3733800"/>
            <a:ext cx="1066800" cy="6096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5791200" y="4648200"/>
            <a:ext cx="1066800" cy="1524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V="1">
            <a:off x="6206320" y="5049672"/>
            <a:ext cx="609600" cy="1524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6213144" y="5493224"/>
            <a:ext cx="685800" cy="3048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394"/>
          <p:cNvGrpSpPr>
            <a:grpSpLocks/>
          </p:cNvGrpSpPr>
          <p:nvPr/>
        </p:nvGrpSpPr>
        <p:grpSpPr bwMode="auto">
          <a:xfrm>
            <a:off x="1920875" y="249237"/>
            <a:ext cx="7146925" cy="2507186"/>
            <a:chOff x="1018615" y="2057400"/>
            <a:chExt cx="7159931" cy="2507413"/>
          </a:xfrm>
        </p:grpSpPr>
        <p:grpSp>
          <p:nvGrpSpPr>
            <p:cNvPr id="5" name="Group 121"/>
            <p:cNvGrpSpPr>
              <a:grpSpLocks/>
            </p:cNvGrpSpPr>
            <p:nvPr/>
          </p:nvGrpSpPr>
          <p:grpSpPr bwMode="auto">
            <a:xfrm>
              <a:off x="1018615" y="2365403"/>
              <a:ext cx="7159931" cy="2199410"/>
              <a:chOff x="2169501" y="2203848"/>
              <a:chExt cx="9338733" cy="2805846"/>
            </a:xfrm>
          </p:grpSpPr>
          <p:grpSp>
            <p:nvGrpSpPr>
              <p:cNvPr id="7" name="Group 122"/>
              <p:cNvGrpSpPr>
                <a:grpSpLocks/>
              </p:cNvGrpSpPr>
              <p:nvPr/>
            </p:nvGrpSpPr>
            <p:grpSpPr bwMode="auto">
              <a:xfrm>
                <a:off x="2961989" y="3148591"/>
                <a:ext cx="485775" cy="1000125"/>
                <a:chOff x="5853112" y="3041015"/>
                <a:chExt cx="485775" cy="1000125"/>
              </a:xfrm>
            </p:grpSpPr>
            <p:sp>
              <p:nvSpPr>
                <p:cNvPr id="87" name="Oval 86"/>
                <p:cNvSpPr/>
                <p:nvPr/>
              </p:nvSpPr>
              <p:spPr>
                <a:xfrm rot="5400000">
                  <a:off x="5595453" y="3297682"/>
                  <a:ext cx="1000547" cy="485399"/>
                </a:xfrm>
                <a:prstGeom prst="ellipse">
                  <a:avLst/>
                </a:prstGeom>
                <a:solidFill>
                  <a:schemeClr val="accent4">
                    <a:lumMod val="40000"/>
                    <a:lumOff val="6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8" name="Freeform 87"/>
                <p:cNvSpPr/>
                <p:nvPr/>
              </p:nvSpPr>
              <p:spPr>
                <a:xfrm>
                  <a:off x="6023124" y="3072514"/>
                  <a:ext cx="114090" cy="190388"/>
                </a:xfrm>
                <a:custGeom>
                  <a:avLst/>
                  <a:gdLst>
                    <a:gd name="connsiteX0" fmla="*/ 115348 w 115348"/>
                    <a:gd name="connsiteY0" fmla="*/ 0 h 190500"/>
                    <a:gd name="connsiteX1" fmla="*/ 96298 w 115348"/>
                    <a:gd name="connsiteY1" fmla="*/ 161925 h 190500"/>
                    <a:gd name="connsiteX2" fmla="*/ 77248 w 115348"/>
                    <a:gd name="connsiteY2" fmla="*/ 190500 h 190500"/>
                    <a:gd name="connsiteX3" fmla="*/ 20098 w 115348"/>
                    <a:gd name="connsiteY3" fmla="*/ 133350 h 190500"/>
                    <a:gd name="connsiteX4" fmla="*/ 1048 w 115348"/>
                    <a:gd name="connsiteY4" fmla="*/ 161925 h 190500"/>
                    <a:gd name="connsiteX5" fmla="*/ 1048 w 115348"/>
                    <a:gd name="connsiteY5" fmla="*/ 180975 h 1905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</a:cxnLst>
                  <a:rect l="l" t="t" r="r" b="b"/>
                  <a:pathLst>
                    <a:path w="115348" h="190500">
                      <a:moveTo>
                        <a:pt x="115348" y="0"/>
                      </a:moveTo>
                      <a:cubicBezTo>
                        <a:pt x="113843" y="21070"/>
                        <a:pt x="117947" y="118627"/>
                        <a:pt x="96298" y="161925"/>
                      </a:cubicBezTo>
                      <a:cubicBezTo>
                        <a:pt x="91178" y="172164"/>
                        <a:pt x="83598" y="180975"/>
                        <a:pt x="77248" y="190500"/>
                      </a:cubicBezTo>
                      <a:cubicBezTo>
                        <a:pt x="74555" y="186910"/>
                        <a:pt x="38265" y="129717"/>
                        <a:pt x="20098" y="133350"/>
                      </a:cubicBezTo>
                      <a:cubicBezTo>
                        <a:pt x="8873" y="135595"/>
                        <a:pt x="5300" y="151296"/>
                        <a:pt x="1048" y="161925"/>
                      </a:cubicBezTo>
                      <a:cubicBezTo>
                        <a:pt x="-1310" y="167821"/>
                        <a:pt x="1048" y="174625"/>
                        <a:pt x="1048" y="180975"/>
                      </a:cubicBezTo>
                    </a:path>
                  </a:pathLst>
                </a:custGeom>
                <a:noFill/>
                <a:ln>
                  <a:solidFill>
                    <a:srgbClr val="00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9" name="Freeform 88"/>
                <p:cNvSpPr/>
                <p:nvPr/>
              </p:nvSpPr>
              <p:spPr>
                <a:xfrm>
                  <a:off x="6137214" y="3167709"/>
                  <a:ext cx="95420" cy="153930"/>
                </a:xfrm>
                <a:custGeom>
                  <a:avLst/>
                  <a:gdLst>
                    <a:gd name="connsiteX0" fmla="*/ 9839 w 95564"/>
                    <a:gd name="connsiteY0" fmla="*/ 0 h 152400"/>
                    <a:gd name="connsiteX1" fmla="*/ 9839 w 95564"/>
                    <a:gd name="connsiteY1" fmla="*/ 104775 h 152400"/>
                    <a:gd name="connsiteX2" fmla="*/ 38414 w 95564"/>
                    <a:gd name="connsiteY2" fmla="*/ 114300 h 152400"/>
                    <a:gd name="connsiteX3" fmla="*/ 95564 w 95564"/>
                    <a:gd name="connsiteY3" fmla="*/ 152400 h 1524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95564" h="152400">
                      <a:moveTo>
                        <a:pt x="9839" y="0"/>
                      </a:moveTo>
                      <a:cubicBezTo>
                        <a:pt x="5064" y="28653"/>
                        <a:pt x="-9686" y="75487"/>
                        <a:pt x="9839" y="104775"/>
                      </a:cubicBezTo>
                      <a:cubicBezTo>
                        <a:pt x="15408" y="113129"/>
                        <a:pt x="29637" y="109424"/>
                        <a:pt x="38414" y="114300"/>
                      </a:cubicBezTo>
                      <a:cubicBezTo>
                        <a:pt x="58428" y="125419"/>
                        <a:pt x="95564" y="152400"/>
                        <a:pt x="95564" y="152400"/>
                      </a:cubicBezTo>
                    </a:path>
                  </a:pathLst>
                </a:custGeom>
                <a:noFill/>
                <a:ln>
                  <a:solidFill>
                    <a:srgbClr val="00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90" name="Freeform 89"/>
                <p:cNvSpPr/>
                <p:nvPr/>
              </p:nvSpPr>
              <p:spPr>
                <a:xfrm>
                  <a:off x="6110247" y="3206191"/>
                  <a:ext cx="37338" cy="143804"/>
                </a:xfrm>
                <a:custGeom>
                  <a:avLst/>
                  <a:gdLst>
                    <a:gd name="connsiteX0" fmla="*/ 28575 w 38100"/>
                    <a:gd name="connsiteY0" fmla="*/ 0 h 142875"/>
                    <a:gd name="connsiteX1" fmla="*/ 9525 w 38100"/>
                    <a:gd name="connsiteY1" fmla="*/ 47625 h 142875"/>
                    <a:gd name="connsiteX2" fmla="*/ 0 w 38100"/>
                    <a:gd name="connsiteY2" fmla="*/ 76200 h 142875"/>
                    <a:gd name="connsiteX3" fmla="*/ 9525 w 38100"/>
                    <a:gd name="connsiteY3" fmla="*/ 133350 h 142875"/>
                    <a:gd name="connsiteX4" fmla="*/ 38100 w 38100"/>
                    <a:gd name="connsiteY4" fmla="*/ 142875 h 1428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8100" h="142875">
                      <a:moveTo>
                        <a:pt x="28575" y="0"/>
                      </a:moveTo>
                      <a:cubicBezTo>
                        <a:pt x="22225" y="15875"/>
                        <a:pt x="15528" y="31616"/>
                        <a:pt x="9525" y="47625"/>
                      </a:cubicBezTo>
                      <a:cubicBezTo>
                        <a:pt x="6000" y="57026"/>
                        <a:pt x="0" y="66160"/>
                        <a:pt x="0" y="76200"/>
                      </a:cubicBezTo>
                      <a:cubicBezTo>
                        <a:pt x="0" y="95513"/>
                        <a:pt x="-57" y="116582"/>
                        <a:pt x="9525" y="133350"/>
                      </a:cubicBezTo>
                      <a:cubicBezTo>
                        <a:pt x="14506" y="142067"/>
                        <a:pt x="38100" y="142875"/>
                        <a:pt x="38100" y="142875"/>
                      </a:cubicBezTo>
                    </a:path>
                  </a:pathLst>
                </a:custGeom>
                <a:noFill/>
                <a:ln>
                  <a:solidFill>
                    <a:srgbClr val="0033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cxnSp>
              <p:nvCxnSpPr>
                <p:cNvPr id="91" name="Straight Connector 90"/>
                <p:cNvCxnSpPr/>
                <p:nvPr/>
              </p:nvCxnSpPr>
              <p:spPr>
                <a:xfrm>
                  <a:off x="6213965" y="3435061"/>
                  <a:ext cx="76752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/>
                <p:cNvCxnSpPr/>
                <p:nvPr/>
              </p:nvCxnSpPr>
              <p:spPr>
                <a:xfrm flipV="1">
                  <a:off x="6081206" y="3435061"/>
                  <a:ext cx="8504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Straight Connector 92"/>
                <p:cNvCxnSpPr/>
                <p:nvPr/>
              </p:nvCxnSpPr>
              <p:spPr>
                <a:xfrm>
                  <a:off x="5890365" y="3435061"/>
                  <a:ext cx="47711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Connector 93"/>
                <p:cNvCxnSpPr/>
                <p:nvPr/>
              </p:nvCxnSpPr>
              <p:spPr>
                <a:xfrm>
                  <a:off x="5977488" y="3435061"/>
                  <a:ext cx="5600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4" name="Picture 405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 rot="19358827" flipV="1">
                <a:off x="2303905" y="2491989"/>
                <a:ext cx="555528" cy="10261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8" name="Group 124"/>
              <p:cNvGrpSpPr>
                <a:grpSpLocks/>
              </p:cNvGrpSpPr>
              <p:nvPr/>
            </p:nvGrpSpPr>
            <p:grpSpPr bwMode="auto">
              <a:xfrm>
                <a:off x="3956210" y="2515278"/>
                <a:ext cx="1121093" cy="544195"/>
                <a:chOff x="4364516" y="2193111"/>
                <a:chExt cx="1121093" cy="544195"/>
              </a:xfrm>
            </p:grpSpPr>
            <p:sp>
              <p:nvSpPr>
                <p:cNvPr id="82" name="Oval 81"/>
                <p:cNvSpPr/>
                <p:nvPr/>
              </p:nvSpPr>
              <p:spPr>
                <a:xfrm>
                  <a:off x="4363825" y="2193592"/>
                  <a:ext cx="1122223" cy="542807"/>
                </a:xfrm>
                <a:prstGeom prst="ellipse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3" name="Freeform 82"/>
                <p:cNvSpPr/>
                <p:nvPr/>
              </p:nvSpPr>
              <p:spPr>
                <a:xfrm>
                  <a:off x="4459245" y="2404233"/>
                  <a:ext cx="931383" cy="66839"/>
                </a:xfrm>
                <a:custGeom>
                  <a:avLst/>
                  <a:gdLst>
                    <a:gd name="connsiteX0" fmla="*/ 0 w 1314450"/>
                    <a:gd name="connsiteY0" fmla="*/ 66675 h 95250"/>
                    <a:gd name="connsiteX1" fmla="*/ 47625 w 1314450"/>
                    <a:gd name="connsiteY1" fmla="*/ 38100 h 95250"/>
                    <a:gd name="connsiteX2" fmla="*/ 76200 w 1314450"/>
                    <a:gd name="connsiteY2" fmla="*/ 19050 h 95250"/>
                    <a:gd name="connsiteX3" fmla="*/ 133350 w 1314450"/>
                    <a:gd name="connsiteY3" fmla="*/ 0 h 95250"/>
                    <a:gd name="connsiteX4" fmla="*/ 314325 w 1314450"/>
                    <a:gd name="connsiteY4" fmla="*/ 9525 h 95250"/>
                    <a:gd name="connsiteX5" fmla="*/ 400050 w 1314450"/>
                    <a:gd name="connsiteY5" fmla="*/ 47625 h 95250"/>
                    <a:gd name="connsiteX6" fmla="*/ 457200 w 1314450"/>
                    <a:gd name="connsiteY6" fmla="*/ 66675 h 95250"/>
                    <a:gd name="connsiteX7" fmla="*/ 485775 w 1314450"/>
                    <a:gd name="connsiteY7" fmla="*/ 76200 h 95250"/>
                    <a:gd name="connsiteX8" fmla="*/ 733425 w 1314450"/>
                    <a:gd name="connsiteY8" fmla="*/ 95250 h 95250"/>
                    <a:gd name="connsiteX9" fmla="*/ 1076325 w 1314450"/>
                    <a:gd name="connsiteY9" fmla="*/ 76200 h 95250"/>
                    <a:gd name="connsiteX10" fmla="*/ 1162050 w 1314450"/>
                    <a:gd name="connsiteY10" fmla="*/ 47625 h 95250"/>
                    <a:gd name="connsiteX11" fmla="*/ 1190625 w 1314450"/>
                    <a:gd name="connsiteY11" fmla="*/ 38100 h 95250"/>
                    <a:gd name="connsiteX12" fmla="*/ 1314450 w 1314450"/>
                    <a:gd name="connsiteY12" fmla="*/ 28575 h 952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1314450" h="95250">
                      <a:moveTo>
                        <a:pt x="0" y="66675"/>
                      </a:moveTo>
                      <a:cubicBezTo>
                        <a:pt x="15875" y="57150"/>
                        <a:pt x="31926" y="47912"/>
                        <a:pt x="47625" y="38100"/>
                      </a:cubicBezTo>
                      <a:cubicBezTo>
                        <a:pt x="57333" y="32033"/>
                        <a:pt x="65739" y="23699"/>
                        <a:pt x="76200" y="19050"/>
                      </a:cubicBezTo>
                      <a:cubicBezTo>
                        <a:pt x="94550" y="10895"/>
                        <a:pt x="133350" y="0"/>
                        <a:pt x="133350" y="0"/>
                      </a:cubicBezTo>
                      <a:cubicBezTo>
                        <a:pt x="193675" y="3175"/>
                        <a:pt x="254347" y="2328"/>
                        <a:pt x="314325" y="9525"/>
                      </a:cubicBezTo>
                      <a:cubicBezTo>
                        <a:pt x="392021" y="18849"/>
                        <a:pt x="349245" y="25045"/>
                        <a:pt x="400050" y="47625"/>
                      </a:cubicBezTo>
                      <a:cubicBezTo>
                        <a:pt x="418400" y="55780"/>
                        <a:pt x="438150" y="60325"/>
                        <a:pt x="457200" y="66675"/>
                      </a:cubicBezTo>
                      <a:cubicBezTo>
                        <a:pt x="466725" y="69850"/>
                        <a:pt x="475754" y="75574"/>
                        <a:pt x="485775" y="76200"/>
                      </a:cubicBezTo>
                      <a:cubicBezTo>
                        <a:pt x="670021" y="87715"/>
                        <a:pt x="587528" y="80660"/>
                        <a:pt x="733425" y="95250"/>
                      </a:cubicBezTo>
                      <a:cubicBezTo>
                        <a:pt x="747998" y="94588"/>
                        <a:pt x="1025867" y="83769"/>
                        <a:pt x="1076325" y="76200"/>
                      </a:cubicBezTo>
                      <a:lnTo>
                        <a:pt x="1162050" y="47625"/>
                      </a:lnTo>
                      <a:cubicBezTo>
                        <a:pt x="1171575" y="44450"/>
                        <a:pt x="1180780" y="40069"/>
                        <a:pt x="1190625" y="38100"/>
                      </a:cubicBezTo>
                      <a:cubicBezTo>
                        <a:pt x="1263157" y="23594"/>
                        <a:pt x="1222061" y="28575"/>
                        <a:pt x="1314450" y="28575"/>
                      </a:cubicBez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4" name="Freeform 83"/>
                <p:cNvSpPr/>
                <p:nvPr/>
              </p:nvSpPr>
              <p:spPr>
                <a:xfrm>
                  <a:off x="4633490" y="2221948"/>
                  <a:ext cx="431465" cy="202540"/>
                </a:xfrm>
                <a:custGeom>
                  <a:avLst/>
                  <a:gdLst>
                    <a:gd name="connsiteX0" fmla="*/ 0 w 590550"/>
                    <a:gd name="connsiteY0" fmla="*/ 304800 h 304800"/>
                    <a:gd name="connsiteX1" fmla="*/ 47625 w 590550"/>
                    <a:gd name="connsiteY1" fmla="*/ 266700 h 304800"/>
                    <a:gd name="connsiteX2" fmla="*/ 104775 w 590550"/>
                    <a:gd name="connsiteY2" fmla="*/ 228600 h 304800"/>
                    <a:gd name="connsiteX3" fmla="*/ 142875 w 590550"/>
                    <a:gd name="connsiteY3" fmla="*/ 219075 h 304800"/>
                    <a:gd name="connsiteX4" fmla="*/ 171450 w 590550"/>
                    <a:gd name="connsiteY4" fmla="*/ 209550 h 304800"/>
                    <a:gd name="connsiteX5" fmla="*/ 419100 w 590550"/>
                    <a:gd name="connsiteY5" fmla="*/ 200025 h 304800"/>
                    <a:gd name="connsiteX6" fmla="*/ 466725 w 590550"/>
                    <a:gd name="connsiteY6" fmla="*/ 190500 h 304800"/>
                    <a:gd name="connsiteX7" fmla="*/ 495300 w 590550"/>
                    <a:gd name="connsiteY7" fmla="*/ 171450 h 304800"/>
                    <a:gd name="connsiteX8" fmla="*/ 552450 w 590550"/>
                    <a:gd name="connsiteY8" fmla="*/ 142875 h 304800"/>
                    <a:gd name="connsiteX9" fmla="*/ 581025 w 590550"/>
                    <a:gd name="connsiteY9" fmla="*/ 57150 h 304800"/>
                    <a:gd name="connsiteX10" fmla="*/ 590550 w 590550"/>
                    <a:gd name="connsiteY10" fmla="*/ 28575 h 304800"/>
                    <a:gd name="connsiteX11" fmla="*/ 590550 w 590550"/>
                    <a:gd name="connsiteY11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590550" h="304800">
                      <a:moveTo>
                        <a:pt x="0" y="304800"/>
                      </a:moveTo>
                      <a:cubicBezTo>
                        <a:pt x="15875" y="292100"/>
                        <a:pt x="31183" y="278657"/>
                        <a:pt x="47625" y="266700"/>
                      </a:cubicBezTo>
                      <a:cubicBezTo>
                        <a:pt x="66141" y="253234"/>
                        <a:pt x="82563" y="234153"/>
                        <a:pt x="104775" y="228600"/>
                      </a:cubicBezTo>
                      <a:cubicBezTo>
                        <a:pt x="117475" y="225425"/>
                        <a:pt x="130288" y="222671"/>
                        <a:pt x="142875" y="219075"/>
                      </a:cubicBezTo>
                      <a:cubicBezTo>
                        <a:pt x="152529" y="216317"/>
                        <a:pt x="161434" y="210241"/>
                        <a:pt x="171450" y="209550"/>
                      </a:cubicBezTo>
                      <a:cubicBezTo>
                        <a:pt x="253865" y="203866"/>
                        <a:pt x="336550" y="203200"/>
                        <a:pt x="419100" y="200025"/>
                      </a:cubicBezTo>
                      <a:cubicBezTo>
                        <a:pt x="434975" y="196850"/>
                        <a:pt x="451566" y="196184"/>
                        <a:pt x="466725" y="190500"/>
                      </a:cubicBezTo>
                      <a:cubicBezTo>
                        <a:pt x="477444" y="186480"/>
                        <a:pt x="485061" y="176570"/>
                        <a:pt x="495300" y="171450"/>
                      </a:cubicBezTo>
                      <a:cubicBezTo>
                        <a:pt x="574170" y="132015"/>
                        <a:pt x="470558" y="197470"/>
                        <a:pt x="552450" y="142875"/>
                      </a:cubicBezTo>
                      <a:lnTo>
                        <a:pt x="581025" y="57150"/>
                      </a:lnTo>
                      <a:cubicBezTo>
                        <a:pt x="584200" y="47625"/>
                        <a:pt x="590550" y="38615"/>
                        <a:pt x="590550" y="28575"/>
                      </a:cubicBezTo>
                      <a:lnTo>
                        <a:pt x="590550" y="0"/>
                      </a:ln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5" name="Freeform 84"/>
                <p:cNvSpPr/>
                <p:nvPr/>
              </p:nvSpPr>
              <p:spPr>
                <a:xfrm>
                  <a:off x="4423980" y="2424487"/>
                  <a:ext cx="835964" cy="257226"/>
                </a:xfrm>
                <a:custGeom>
                  <a:avLst/>
                  <a:gdLst>
                    <a:gd name="connsiteX0" fmla="*/ 0 w 1143000"/>
                    <a:gd name="connsiteY0" fmla="*/ 0 h 390525"/>
                    <a:gd name="connsiteX1" fmla="*/ 114300 w 1143000"/>
                    <a:gd name="connsiteY1" fmla="*/ 9525 h 390525"/>
                    <a:gd name="connsiteX2" fmla="*/ 171450 w 1143000"/>
                    <a:gd name="connsiteY2" fmla="*/ 28575 h 390525"/>
                    <a:gd name="connsiteX3" fmla="*/ 190500 w 1143000"/>
                    <a:gd name="connsiteY3" fmla="*/ 57150 h 390525"/>
                    <a:gd name="connsiteX4" fmla="*/ 247650 w 1143000"/>
                    <a:gd name="connsiteY4" fmla="*/ 114300 h 390525"/>
                    <a:gd name="connsiteX5" fmla="*/ 295275 w 1143000"/>
                    <a:gd name="connsiteY5" fmla="*/ 209550 h 390525"/>
                    <a:gd name="connsiteX6" fmla="*/ 333375 w 1143000"/>
                    <a:gd name="connsiteY6" fmla="*/ 266700 h 390525"/>
                    <a:gd name="connsiteX7" fmla="*/ 361950 w 1143000"/>
                    <a:gd name="connsiteY7" fmla="*/ 276225 h 390525"/>
                    <a:gd name="connsiteX8" fmla="*/ 381000 w 1143000"/>
                    <a:gd name="connsiteY8" fmla="*/ 304800 h 390525"/>
                    <a:gd name="connsiteX9" fmla="*/ 409575 w 1143000"/>
                    <a:gd name="connsiteY9" fmla="*/ 314325 h 390525"/>
                    <a:gd name="connsiteX10" fmla="*/ 447675 w 1143000"/>
                    <a:gd name="connsiteY10" fmla="*/ 333375 h 390525"/>
                    <a:gd name="connsiteX11" fmla="*/ 504825 w 1143000"/>
                    <a:gd name="connsiteY11" fmla="*/ 352425 h 390525"/>
                    <a:gd name="connsiteX12" fmla="*/ 581025 w 1143000"/>
                    <a:gd name="connsiteY12" fmla="*/ 371475 h 390525"/>
                    <a:gd name="connsiteX13" fmla="*/ 723900 w 1143000"/>
                    <a:gd name="connsiteY13" fmla="*/ 390525 h 390525"/>
                    <a:gd name="connsiteX14" fmla="*/ 876300 w 1143000"/>
                    <a:gd name="connsiteY14" fmla="*/ 381000 h 390525"/>
                    <a:gd name="connsiteX15" fmla="*/ 933450 w 1143000"/>
                    <a:gd name="connsiteY15" fmla="*/ 352425 h 390525"/>
                    <a:gd name="connsiteX16" fmla="*/ 990600 w 1143000"/>
                    <a:gd name="connsiteY16" fmla="*/ 333375 h 390525"/>
                    <a:gd name="connsiteX17" fmla="*/ 1019175 w 1143000"/>
                    <a:gd name="connsiteY17" fmla="*/ 323850 h 390525"/>
                    <a:gd name="connsiteX18" fmla="*/ 1104900 w 1143000"/>
                    <a:gd name="connsiteY18" fmla="*/ 266700 h 390525"/>
                    <a:gd name="connsiteX19" fmla="*/ 1143000 w 1143000"/>
                    <a:gd name="connsiteY19" fmla="*/ 238125 h 390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1143000" h="390525">
                      <a:moveTo>
                        <a:pt x="0" y="0"/>
                      </a:moveTo>
                      <a:cubicBezTo>
                        <a:pt x="38100" y="3175"/>
                        <a:pt x="76588" y="3240"/>
                        <a:pt x="114300" y="9525"/>
                      </a:cubicBezTo>
                      <a:cubicBezTo>
                        <a:pt x="134107" y="12826"/>
                        <a:pt x="171450" y="28575"/>
                        <a:pt x="171450" y="28575"/>
                      </a:cubicBezTo>
                      <a:cubicBezTo>
                        <a:pt x="177800" y="38100"/>
                        <a:pt x="182895" y="48594"/>
                        <a:pt x="190500" y="57150"/>
                      </a:cubicBezTo>
                      <a:cubicBezTo>
                        <a:pt x="208398" y="77286"/>
                        <a:pt x="247650" y="114300"/>
                        <a:pt x="247650" y="114300"/>
                      </a:cubicBezTo>
                      <a:cubicBezTo>
                        <a:pt x="271720" y="186510"/>
                        <a:pt x="254652" y="155386"/>
                        <a:pt x="295275" y="209550"/>
                      </a:cubicBezTo>
                      <a:cubicBezTo>
                        <a:pt x="305261" y="239508"/>
                        <a:pt x="302797" y="246315"/>
                        <a:pt x="333375" y="266700"/>
                      </a:cubicBezTo>
                      <a:cubicBezTo>
                        <a:pt x="341729" y="272269"/>
                        <a:pt x="352425" y="273050"/>
                        <a:pt x="361950" y="276225"/>
                      </a:cubicBezTo>
                      <a:cubicBezTo>
                        <a:pt x="368300" y="285750"/>
                        <a:pt x="372061" y="297649"/>
                        <a:pt x="381000" y="304800"/>
                      </a:cubicBezTo>
                      <a:cubicBezTo>
                        <a:pt x="388840" y="311072"/>
                        <a:pt x="400347" y="310370"/>
                        <a:pt x="409575" y="314325"/>
                      </a:cubicBezTo>
                      <a:cubicBezTo>
                        <a:pt x="422626" y="319918"/>
                        <a:pt x="434492" y="328102"/>
                        <a:pt x="447675" y="333375"/>
                      </a:cubicBezTo>
                      <a:cubicBezTo>
                        <a:pt x="466319" y="340833"/>
                        <a:pt x="485775" y="346075"/>
                        <a:pt x="504825" y="352425"/>
                      </a:cubicBezTo>
                      <a:cubicBezTo>
                        <a:pt x="536878" y="363109"/>
                        <a:pt x="542711" y="366367"/>
                        <a:pt x="581025" y="371475"/>
                      </a:cubicBezTo>
                      <a:cubicBezTo>
                        <a:pt x="748064" y="393747"/>
                        <a:pt x="616736" y="369092"/>
                        <a:pt x="723900" y="390525"/>
                      </a:cubicBezTo>
                      <a:cubicBezTo>
                        <a:pt x="774700" y="387350"/>
                        <a:pt x="825681" y="386328"/>
                        <a:pt x="876300" y="381000"/>
                      </a:cubicBezTo>
                      <a:cubicBezTo>
                        <a:pt x="910439" y="377406"/>
                        <a:pt x="902560" y="366154"/>
                        <a:pt x="933450" y="352425"/>
                      </a:cubicBezTo>
                      <a:cubicBezTo>
                        <a:pt x="951800" y="344270"/>
                        <a:pt x="971550" y="339725"/>
                        <a:pt x="990600" y="333375"/>
                      </a:cubicBezTo>
                      <a:cubicBezTo>
                        <a:pt x="1000125" y="330200"/>
                        <a:pt x="1010821" y="329419"/>
                        <a:pt x="1019175" y="323850"/>
                      </a:cubicBezTo>
                      <a:lnTo>
                        <a:pt x="1104900" y="266700"/>
                      </a:lnTo>
                      <a:cubicBezTo>
                        <a:pt x="1137211" y="245159"/>
                        <a:pt x="1125380" y="255745"/>
                        <a:pt x="1143000" y="238125"/>
                      </a:cubicBez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6" name="Freeform 85"/>
                <p:cNvSpPr/>
                <p:nvPr/>
              </p:nvSpPr>
              <p:spPr>
                <a:xfrm>
                  <a:off x="4820182" y="2347522"/>
                  <a:ext cx="526885" cy="44559"/>
                </a:xfrm>
                <a:custGeom>
                  <a:avLst/>
                  <a:gdLst>
                    <a:gd name="connsiteX0" fmla="*/ 0 w 400050"/>
                    <a:gd name="connsiteY0" fmla="*/ 9525 h 38100"/>
                    <a:gd name="connsiteX1" fmla="*/ 133350 w 400050"/>
                    <a:gd name="connsiteY1" fmla="*/ 19050 h 38100"/>
                    <a:gd name="connsiteX2" fmla="*/ 161925 w 400050"/>
                    <a:gd name="connsiteY2" fmla="*/ 28575 h 38100"/>
                    <a:gd name="connsiteX3" fmla="*/ 219075 w 400050"/>
                    <a:gd name="connsiteY3" fmla="*/ 38100 h 38100"/>
                    <a:gd name="connsiteX4" fmla="*/ 342900 w 400050"/>
                    <a:gd name="connsiteY4" fmla="*/ 28575 h 38100"/>
                    <a:gd name="connsiteX5" fmla="*/ 371475 w 400050"/>
                    <a:gd name="connsiteY5" fmla="*/ 19050 h 38100"/>
                    <a:gd name="connsiteX6" fmla="*/ 400050 w 400050"/>
                    <a:gd name="connsiteY6" fmla="*/ 0 h 381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400050" h="38100">
                      <a:moveTo>
                        <a:pt x="0" y="9525"/>
                      </a:moveTo>
                      <a:cubicBezTo>
                        <a:pt x="44450" y="12700"/>
                        <a:pt x="89092" y="13843"/>
                        <a:pt x="133350" y="19050"/>
                      </a:cubicBezTo>
                      <a:cubicBezTo>
                        <a:pt x="143321" y="20223"/>
                        <a:pt x="152124" y="26397"/>
                        <a:pt x="161925" y="28575"/>
                      </a:cubicBezTo>
                      <a:cubicBezTo>
                        <a:pt x="180778" y="32765"/>
                        <a:pt x="200025" y="34925"/>
                        <a:pt x="219075" y="38100"/>
                      </a:cubicBezTo>
                      <a:cubicBezTo>
                        <a:pt x="260350" y="34925"/>
                        <a:pt x="301823" y="33710"/>
                        <a:pt x="342900" y="28575"/>
                      </a:cubicBezTo>
                      <a:cubicBezTo>
                        <a:pt x="352863" y="27330"/>
                        <a:pt x="362495" y="23540"/>
                        <a:pt x="371475" y="19050"/>
                      </a:cubicBezTo>
                      <a:cubicBezTo>
                        <a:pt x="381714" y="13930"/>
                        <a:pt x="400050" y="0"/>
                        <a:pt x="400050" y="0"/>
                      </a:cubicBez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</p:grpSp>
          <p:sp>
            <p:nvSpPr>
              <p:cNvPr id="47" name="Flowchart: Delay 46"/>
              <p:cNvSpPr/>
              <p:nvPr/>
            </p:nvSpPr>
            <p:spPr>
              <a:xfrm rot="5400000">
                <a:off x="4170361" y="3578332"/>
                <a:ext cx="698764" cy="493696"/>
              </a:xfrm>
              <a:prstGeom prst="flowChartDelay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68580" tIns="34290" rIns="68580" bIns="34290" anchor="ctr"/>
              <a:lstStyle/>
              <a:p>
                <a:pPr>
                  <a:defRPr/>
                </a:pPr>
                <a:endParaRPr lang="en-US" sz="1350"/>
              </a:p>
            </p:txBody>
          </p:sp>
          <p:sp>
            <p:nvSpPr>
              <p:cNvPr id="48" name="Right Arrow 47"/>
              <p:cNvSpPr/>
              <p:nvPr/>
            </p:nvSpPr>
            <p:spPr>
              <a:xfrm>
                <a:off x="3532351" y="3694542"/>
                <a:ext cx="562149" cy="115448"/>
              </a:xfrm>
              <a:prstGeom prst="rightArrow">
                <a:avLst/>
              </a:prstGeom>
              <a:solidFill>
                <a:srgbClr val="00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68580" tIns="34290" rIns="68580" bIns="34290" anchor="ctr"/>
              <a:lstStyle/>
              <a:p>
                <a:pPr>
                  <a:defRPr/>
                </a:pPr>
                <a:endParaRPr lang="en-US" sz="1350"/>
              </a:p>
            </p:txBody>
          </p:sp>
          <p:sp>
            <p:nvSpPr>
              <p:cNvPr id="49" name="Freeform 48"/>
              <p:cNvSpPr/>
              <p:nvPr/>
            </p:nvSpPr>
            <p:spPr>
              <a:xfrm>
                <a:off x="4436769" y="3627704"/>
                <a:ext cx="72602" cy="95193"/>
              </a:xfrm>
              <a:custGeom>
                <a:avLst/>
                <a:gdLst>
                  <a:gd name="connsiteX0" fmla="*/ 19075 w 19075"/>
                  <a:gd name="connsiteY0" fmla="*/ 0 h 133350"/>
                  <a:gd name="connsiteX1" fmla="*/ 9550 w 19075"/>
                  <a:gd name="connsiteY1" fmla="*/ 95250 h 133350"/>
                  <a:gd name="connsiteX2" fmla="*/ 25 w 19075"/>
                  <a:gd name="connsiteY2" fmla="*/ 133350 h 1333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9075" h="133350">
                    <a:moveTo>
                      <a:pt x="19075" y="0"/>
                    </a:moveTo>
                    <a:cubicBezTo>
                      <a:pt x="15900" y="31750"/>
                      <a:pt x="14402" y="63713"/>
                      <a:pt x="9550" y="95250"/>
                    </a:cubicBezTo>
                    <a:cubicBezTo>
                      <a:pt x="-979" y="163689"/>
                      <a:pt x="25" y="102131"/>
                      <a:pt x="25" y="133350"/>
                    </a:cubicBezTo>
                  </a:path>
                </a:pathLst>
              </a:cu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68580" tIns="34290" rIns="68580" bIns="34290" anchor="ctr"/>
              <a:lstStyle/>
              <a:p>
                <a:pPr>
                  <a:defRPr/>
                </a:pPr>
                <a:endParaRPr lang="en-US" sz="1350"/>
              </a:p>
            </p:txBody>
          </p:sp>
          <p:sp>
            <p:nvSpPr>
              <p:cNvPr id="50" name="Flowchart: Delay 49"/>
              <p:cNvSpPr/>
              <p:nvPr/>
            </p:nvSpPr>
            <p:spPr>
              <a:xfrm rot="5400000">
                <a:off x="5459570" y="3599623"/>
                <a:ext cx="698764" cy="491622"/>
              </a:xfrm>
              <a:prstGeom prst="flowChartDelay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68580" tIns="34290" rIns="68580" bIns="34290" anchor="ctr"/>
              <a:lstStyle/>
              <a:p>
                <a:pPr>
                  <a:defRPr/>
                </a:pPr>
                <a:endParaRPr lang="en-US" sz="1350"/>
              </a:p>
            </p:txBody>
          </p:sp>
          <p:grpSp>
            <p:nvGrpSpPr>
              <p:cNvPr id="9" name="Group 133"/>
              <p:cNvGrpSpPr>
                <a:grpSpLocks/>
              </p:cNvGrpSpPr>
              <p:nvPr/>
            </p:nvGrpSpPr>
            <p:grpSpPr bwMode="auto">
              <a:xfrm>
                <a:off x="5631082" y="3503798"/>
                <a:ext cx="403860" cy="591185"/>
                <a:chOff x="5631082" y="3503798"/>
                <a:chExt cx="403860" cy="591185"/>
              </a:xfrm>
            </p:grpSpPr>
            <p:sp>
              <p:nvSpPr>
                <p:cNvPr id="78" name="Freeform 77"/>
                <p:cNvSpPr/>
                <p:nvPr/>
              </p:nvSpPr>
              <p:spPr>
                <a:xfrm rot="5156497">
                  <a:off x="5453088" y="3682661"/>
                  <a:ext cx="591417" cy="234401"/>
                </a:xfrm>
                <a:custGeom>
                  <a:avLst/>
                  <a:gdLst>
                    <a:gd name="connsiteX0" fmla="*/ 0 w 1143000"/>
                    <a:gd name="connsiteY0" fmla="*/ 0 h 390525"/>
                    <a:gd name="connsiteX1" fmla="*/ 114300 w 1143000"/>
                    <a:gd name="connsiteY1" fmla="*/ 9525 h 390525"/>
                    <a:gd name="connsiteX2" fmla="*/ 171450 w 1143000"/>
                    <a:gd name="connsiteY2" fmla="*/ 28575 h 390525"/>
                    <a:gd name="connsiteX3" fmla="*/ 190500 w 1143000"/>
                    <a:gd name="connsiteY3" fmla="*/ 57150 h 390525"/>
                    <a:gd name="connsiteX4" fmla="*/ 247650 w 1143000"/>
                    <a:gd name="connsiteY4" fmla="*/ 114300 h 390525"/>
                    <a:gd name="connsiteX5" fmla="*/ 295275 w 1143000"/>
                    <a:gd name="connsiteY5" fmla="*/ 209550 h 390525"/>
                    <a:gd name="connsiteX6" fmla="*/ 333375 w 1143000"/>
                    <a:gd name="connsiteY6" fmla="*/ 266700 h 390525"/>
                    <a:gd name="connsiteX7" fmla="*/ 361950 w 1143000"/>
                    <a:gd name="connsiteY7" fmla="*/ 276225 h 390525"/>
                    <a:gd name="connsiteX8" fmla="*/ 381000 w 1143000"/>
                    <a:gd name="connsiteY8" fmla="*/ 304800 h 390525"/>
                    <a:gd name="connsiteX9" fmla="*/ 409575 w 1143000"/>
                    <a:gd name="connsiteY9" fmla="*/ 314325 h 390525"/>
                    <a:gd name="connsiteX10" fmla="*/ 447675 w 1143000"/>
                    <a:gd name="connsiteY10" fmla="*/ 333375 h 390525"/>
                    <a:gd name="connsiteX11" fmla="*/ 504825 w 1143000"/>
                    <a:gd name="connsiteY11" fmla="*/ 352425 h 390525"/>
                    <a:gd name="connsiteX12" fmla="*/ 581025 w 1143000"/>
                    <a:gd name="connsiteY12" fmla="*/ 371475 h 390525"/>
                    <a:gd name="connsiteX13" fmla="*/ 723900 w 1143000"/>
                    <a:gd name="connsiteY13" fmla="*/ 390525 h 390525"/>
                    <a:gd name="connsiteX14" fmla="*/ 876300 w 1143000"/>
                    <a:gd name="connsiteY14" fmla="*/ 381000 h 390525"/>
                    <a:gd name="connsiteX15" fmla="*/ 933450 w 1143000"/>
                    <a:gd name="connsiteY15" fmla="*/ 352425 h 390525"/>
                    <a:gd name="connsiteX16" fmla="*/ 990600 w 1143000"/>
                    <a:gd name="connsiteY16" fmla="*/ 333375 h 390525"/>
                    <a:gd name="connsiteX17" fmla="*/ 1019175 w 1143000"/>
                    <a:gd name="connsiteY17" fmla="*/ 323850 h 390525"/>
                    <a:gd name="connsiteX18" fmla="*/ 1104900 w 1143000"/>
                    <a:gd name="connsiteY18" fmla="*/ 266700 h 390525"/>
                    <a:gd name="connsiteX19" fmla="*/ 1143000 w 1143000"/>
                    <a:gd name="connsiteY19" fmla="*/ 238125 h 39052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1143000" h="390525">
                      <a:moveTo>
                        <a:pt x="0" y="0"/>
                      </a:moveTo>
                      <a:cubicBezTo>
                        <a:pt x="38100" y="3175"/>
                        <a:pt x="76588" y="3240"/>
                        <a:pt x="114300" y="9525"/>
                      </a:cubicBezTo>
                      <a:cubicBezTo>
                        <a:pt x="134107" y="12826"/>
                        <a:pt x="171450" y="28575"/>
                        <a:pt x="171450" y="28575"/>
                      </a:cubicBezTo>
                      <a:cubicBezTo>
                        <a:pt x="177800" y="38100"/>
                        <a:pt x="182895" y="48594"/>
                        <a:pt x="190500" y="57150"/>
                      </a:cubicBezTo>
                      <a:cubicBezTo>
                        <a:pt x="208398" y="77286"/>
                        <a:pt x="247650" y="114300"/>
                        <a:pt x="247650" y="114300"/>
                      </a:cubicBezTo>
                      <a:cubicBezTo>
                        <a:pt x="271720" y="186510"/>
                        <a:pt x="254652" y="155386"/>
                        <a:pt x="295275" y="209550"/>
                      </a:cubicBezTo>
                      <a:cubicBezTo>
                        <a:pt x="305261" y="239508"/>
                        <a:pt x="302797" y="246315"/>
                        <a:pt x="333375" y="266700"/>
                      </a:cubicBezTo>
                      <a:cubicBezTo>
                        <a:pt x="341729" y="272269"/>
                        <a:pt x="352425" y="273050"/>
                        <a:pt x="361950" y="276225"/>
                      </a:cubicBezTo>
                      <a:cubicBezTo>
                        <a:pt x="368300" y="285750"/>
                        <a:pt x="372061" y="297649"/>
                        <a:pt x="381000" y="304800"/>
                      </a:cubicBezTo>
                      <a:cubicBezTo>
                        <a:pt x="388840" y="311072"/>
                        <a:pt x="400347" y="310370"/>
                        <a:pt x="409575" y="314325"/>
                      </a:cubicBezTo>
                      <a:cubicBezTo>
                        <a:pt x="422626" y="319918"/>
                        <a:pt x="434492" y="328102"/>
                        <a:pt x="447675" y="333375"/>
                      </a:cubicBezTo>
                      <a:cubicBezTo>
                        <a:pt x="466319" y="340833"/>
                        <a:pt x="485775" y="346075"/>
                        <a:pt x="504825" y="352425"/>
                      </a:cubicBezTo>
                      <a:cubicBezTo>
                        <a:pt x="536878" y="363109"/>
                        <a:pt x="542711" y="366367"/>
                        <a:pt x="581025" y="371475"/>
                      </a:cubicBezTo>
                      <a:cubicBezTo>
                        <a:pt x="748064" y="393747"/>
                        <a:pt x="616736" y="369092"/>
                        <a:pt x="723900" y="390525"/>
                      </a:cubicBezTo>
                      <a:cubicBezTo>
                        <a:pt x="774700" y="387350"/>
                        <a:pt x="825681" y="386328"/>
                        <a:pt x="876300" y="381000"/>
                      </a:cubicBezTo>
                      <a:cubicBezTo>
                        <a:pt x="910439" y="377406"/>
                        <a:pt x="902560" y="366154"/>
                        <a:pt x="933450" y="352425"/>
                      </a:cubicBezTo>
                      <a:cubicBezTo>
                        <a:pt x="951800" y="344270"/>
                        <a:pt x="971550" y="339725"/>
                        <a:pt x="990600" y="333375"/>
                      </a:cubicBezTo>
                      <a:cubicBezTo>
                        <a:pt x="1000125" y="330200"/>
                        <a:pt x="1010821" y="329419"/>
                        <a:pt x="1019175" y="323850"/>
                      </a:cubicBezTo>
                      <a:lnTo>
                        <a:pt x="1104900" y="266700"/>
                      </a:lnTo>
                      <a:cubicBezTo>
                        <a:pt x="1137211" y="245159"/>
                        <a:pt x="1125380" y="255745"/>
                        <a:pt x="1143000" y="238125"/>
                      </a:cubicBez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79" name="Freeform 78"/>
                <p:cNvSpPr/>
                <p:nvPr/>
              </p:nvSpPr>
              <p:spPr>
                <a:xfrm rot="5659386">
                  <a:off x="5736949" y="3685079"/>
                  <a:ext cx="392928" cy="201213"/>
                </a:xfrm>
                <a:custGeom>
                  <a:avLst/>
                  <a:gdLst>
                    <a:gd name="connsiteX0" fmla="*/ 0 w 590550"/>
                    <a:gd name="connsiteY0" fmla="*/ 304800 h 304800"/>
                    <a:gd name="connsiteX1" fmla="*/ 47625 w 590550"/>
                    <a:gd name="connsiteY1" fmla="*/ 266700 h 304800"/>
                    <a:gd name="connsiteX2" fmla="*/ 104775 w 590550"/>
                    <a:gd name="connsiteY2" fmla="*/ 228600 h 304800"/>
                    <a:gd name="connsiteX3" fmla="*/ 142875 w 590550"/>
                    <a:gd name="connsiteY3" fmla="*/ 219075 h 304800"/>
                    <a:gd name="connsiteX4" fmla="*/ 171450 w 590550"/>
                    <a:gd name="connsiteY4" fmla="*/ 209550 h 304800"/>
                    <a:gd name="connsiteX5" fmla="*/ 419100 w 590550"/>
                    <a:gd name="connsiteY5" fmla="*/ 200025 h 304800"/>
                    <a:gd name="connsiteX6" fmla="*/ 466725 w 590550"/>
                    <a:gd name="connsiteY6" fmla="*/ 190500 h 304800"/>
                    <a:gd name="connsiteX7" fmla="*/ 495300 w 590550"/>
                    <a:gd name="connsiteY7" fmla="*/ 171450 h 304800"/>
                    <a:gd name="connsiteX8" fmla="*/ 552450 w 590550"/>
                    <a:gd name="connsiteY8" fmla="*/ 142875 h 304800"/>
                    <a:gd name="connsiteX9" fmla="*/ 581025 w 590550"/>
                    <a:gd name="connsiteY9" fmla="*/ 57150 h 304800"/>
                    <a:gd name="connsiteX10" fmla="*/ 590550 w 590550"/>
                    <a:gd name="connsiteY10" fmla="*/ 28575 h 304800"/>
                    <a:gd name="connsiteX11" fmla="*/ 590550 w 590550"/>
                    <a:gd name="connsiteY11" fmla="*/ 0 h 304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</a:cxnLst>
                  <a:rect l="l" t="t" r="r" b="b"/>
                  <a:pathLst>
                    <a:path w="590550" h="304800">
                      <a:moveTo>
                        <a:pt x="0" y="304800"/>
                      </a:moveTo>
                      <a:cubicBezTo>
                        <a:pt x="15875" y="292100"/>
                        <a:pt x="31183" y="278657"/>
                        <a:pt x="47625" y="266700"/>
                      </a:cubicBezTo>
                      <a:cubicBezTo>
                        <a:pt x="66141" y="253234"/>
                        <a:pt x="82563" y="234153"/>
                        <a:pt x="104775" y="228600"/>
                      </a:cubicBezTo>
                      <a:cubicBezTo>
                        <a:pt x="117475" y="225425"/>
                        <a:pt x="130288" y="222671"/>
                        <a:pt x="142875" y="219075"/>
                      </a:cubicBezTo>
                      <a:cubicBezTo>
                        <a:pt x="152529" y="216317"/>
                        <a:pt x="161434" y="210241"/>
                        <a:pt x="171450" y="209550"/>
                      </a:cubicBezTo>
                      <a:cubicBezTo>
                        <a:pt x="253865" y="203866"/>
                        <a:pt x="336550" y="203200"/>
                        <a:pt x="419100" y="200025"/>
                      </a:cubicBezTo>
                      <a:cubicBezTo>
                        <a:pt x="434975" y="196850"/>
                        <a:pt x="451566" y="196184"/>
                        <a:pt x="466725" y="190500"/>
                      </a:cubicBezTo>
                      <a:cubicBezTo>
                        <a:pt x="477444" y="186480"/>
                        <a:pt x="485061" y="176570"/>
                        <a:pt x="495300" y="171450"/>
                      </a:cubicBezTo>
                      <a:cubicBezTo>
                        <a:pt x="574170" y="132015"/>
                        <a:pt x="470558" y="197470"/>
                        <a:pt x="552450" y="142875"/>
                      </a:cubicBezTo>
                      <a:lnTo>
                        <a:pt x="581025" y="57150"/>
                      </a:lnTo>
                      <a:cubicBezTo>
                        <a:pt x="584200" y="47625"/>
                        <a:pt x="590550" y="38615"/>
                        <a:pt x="590550" y="28575"/>
                      </a:cubicBezTo>
                      <a:lnTo>
                        <a:pt x="590550" y="0"/>
                      </a:ln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>
                    <a:defRPr/>
                  </a:pPr>
                  <a:endParaRPr lang="en-US" sz="1350"/>
                </a:p>
              </p:txBody>
            </p:sp>
            <p:sp>
              <p:nvSpPr>
                <p:cNvPr id="80" name="Freeform 79"/>
                <p:cNvSpPr/>
                <p:nvPr/>
              </p:nvSpPr>
              <p:spPr>
                <a:xfrm>
                  <a:off x="5768503" y="3739101"/>
                  <a:ext cx="120312" cy="309887"/>
                </a:xfrm>
                <a:custGeom>
                  <a:avLst/>
                  <a:gdLst>
                    <a:gd name="connsiteX0" fmla="*/ 121024 w 121024"/>
                    <a:gd name="connsiteY0" fmla="*/ 0 h 309283"/>
                    <a:gd name="connsiteX1" fmla="*/ 67236 w 121024"/>
                    <a:gd name="connsiteY1" fmla="*/ 67236 h 309283"/>
                    <a:gd name="connsiteX2" fmla="*/ 13447 w 121024"/>
                    <a:gd name="connsiteY2" fmla="*/ 228600 h 309283"/>
                    <a:gd name="connsiteX3" fmla="*/ 0 w 121024"/>
                    <a:gd name="connsiteY3" fmla="*/ 268942 h 309283"/>
                    <a:gd name="connsiteX4" fmla="*/ 13447 w 121024"/>
                    <a:gd name="connsiteY4" fmla="*/ 309283 h 3092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21024" h="309283">
                      <a:moveTo>
                        <a:pt x="121024" y="0"/>
                      </a:moveTo>
                      <a:cubicBezTo>
                        <a:pt x="103095" y="22412"/>
                        <a:pt x="76889" y="40207"/>
                        <a:pt x="67236" y="67236"/>
                      </a:cubicBezTo>
                      <a:cubicBezTo>
                        <a:pt x="-1862" y="260710"/>
                        <a:pt x="107578" y="134469"/>
                        <a:pt x="13447" y="228600"/>
                      </a:cubicBezTo>
                      <a:cubicBezTo>
                        <a:pt x="8965" y="242047"/>
                        <a:pt x="0" y="254767"/>
                        <a:pt x="0" y="268942"/>
                      </a:cubicBezTo>
                      <a:cubicBezTo>
                        <a:pt x="0" y="283116"/>
                        <a:pt x="13447" y="309283"/>
                        <a:pt x="13447" y="309283"/>
                      </a:cubicBez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 algn="ctr">
                    <a:defRPr/>
                  </a:pPr>
                  <a:endParaRPr lang="en-US" sz="135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81" name="Freeform 80"/>
                <p:cNvSpPr/>
                <p:nvPr/>
              </p:nvSpPr>
              <p:spPr>
                <a:xfrm>
                  <a:off x="5888815" y="3617576"/>
                  <a:ext cx="134832" cy="255201"/>
                </a:xfrm>
                <a:custGeom>
                  <a:avLst/>
                  <a:gdLst>
                    <a:gd name="connsiteX0" fmla="*/ 0 w 134470"/>
                    <a:gd name="connsiteY0" fmla="*/ 0 h 255494"/>
                    <a:gd name="connsiteX1" fmla="*/ 13447 w 134470"/>
                    <a:gd name="connsiteY1" fmla="*/ 94129 h 255494"/>
                    <a:gd name="connsiteX2" fmla="*/ 94129 w 134470"/>
                    <a:gd name="connsiteY2" fmla="*/ 134470 h 255494"/>
                    <a:gd name="connsiteX3" fmla="*/ 121023 w 134470"/>
                    <a:gd name="connsiteY3" fmla="*/ 161365 h 255494"/>
                    <a:gd name="connsiteX4" fmla="*/ 134470 w 134470"/>
                    <a:gd name="connsiteY4" fmla="*/ 255494 h 25549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34470" h="255494">
                      <a:moveTo>
                        <a:pt x="0" y="0"/>
                      </a:moveTo>
                      <a:cubicBezTo>
                        <a:pt x="4482" y="31376"/>
                        <a:pt x="574" y="65166"/>
                        <a:pt x="13447" y="94129"/>
                      </a:cubicBezTo>
                      <a:cubicBezTo>
                        <a:pt x="22514" y="114530"/>
                        <a:pt x="76229" y="128503"/>
                        <a:pt x="94129" y="134470"/>
                      </a:cubicBezTo>
                      <a:cubicBezTo>
                        <a:pt x="103094" y="143435"/>
                        <a:pt x="117014" y="149337"/>
                        <a:pt x="121023" y="161365"/>
                      </a:cubicBezTo>
                      <a:cubicBezTo>
                        <a:pt x="131046" y="191433"/>
                        <a:pt x="134470" y="255494"/>
                        <a:pt x="134470" y="255494"/>
                      </a:cubicBezTo>
                    </a:path>
                  </a:pathLst>
                </a:cu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68580" tIns="34290" rIns="68580" bIns="34290" anchor="ctr"/>
                <a:lstStyle/>
                <a:p>
                  <a:pPr algn="ctr">
                    <a:defRPr/>
                  </a:pPr>
                  <a:endParaRPr lang="en-US" sz="1350"/>
                </a:p>
              </p:txBody>
            </p:sp>
          </p:grpSp>
          <p:sp>
            <p:nvSpPr>
              <p:cNvPr id="53" name="Text Box 11"/>
              <p:cNvSpPr txBox="1">
                <a:spLocks noChangeArrowheads="1"/>
              </p:cNvSpPr>
              <p:nvPr/>
            </p:nvSpPr>
            <p:spPr bwMode="auto">
              <a:xfrm>
                <a:off x="6629401" y="2796989"/>
                <a:ext cx="1972232" cy="40775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bg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en-US" altLang="en-US" sz="1500" b="1">
                    <a:solidFill>
                      <a:srgbClr val="FF0000"/>
                    </a:solidFill>
                    <a:latin typeface="Times New Roman" pitchFamily="18" charset="0"/>
                  </a:rPr>
                  <a:t>Sham (Control) </a:t>
                </a:r>
              </a:p>
              <a:p>
                <a:endParaRPr lang="en-US" altLang="en-US" sz="1500" b="1">
                  <a:solidFill>
                    <a:srgbClr val="FF0000"/>
                  </a:solidFill>
                  <a:latin typeface="Calibri" pitchFamily="34" charset="0"/>
                </a:endParaRPr>
              </a:p>
            </p:txBody>
          </p:sp>
          <p:sp>
            <p:nvSpPr>
              <p:cNvPr id="55" name="Text Box 13"/>
              <p:cNvSpPr txBox="1">
                <a:spLocks noChangeArrowheads="1"/>
              </p:cNvSpPr>
              <p:nvPr/>
            </p:nvSpPr>
            <p:spPr bwMode="auto">
              <a:xfrm>
                <a:off x="6544232" y="3890542"/>
                <a:ext cx="2674938" cy="37465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bg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en-US" altLang="en-US" sz="1500" b="1">
                    <a:solidFill>
                      <a:srgbClr val="003300"/>
                    </a:solidFill>
                    <a:latin typeface="Times New Roman" pitchFamily="18" charset="0"/>
                  </a:rPr>
                  <a:t>Tamoxifen</a:t>
                </a:r>
                <a:r>
                  <a:rPr lang="en-US" altLang="en-US" sz="1500" b="1">
                    <a:solidFill>
                      <a:srgbClr val="FF0066"/>
                    </a:solidFill>
                    <a:latin typeface="Times New Roman" pitchFamily="18" charset="0"/>
                  </a:rPr>
                  <a:t> </a:t>
                </a:r>
                <a:r>
                  <a:rPr lang="en-US" altLang="en-US" sz="1500" b="1">
                    <a:solidFill>
                      <a:srgbClr val="003300"/>
                    </a:solidFill>
                    <a:latin typeface="Times New Roman" pitchFamily="18" charset="0"/>
                  </a:rPr>
                  <a:t>(5mg) </a:t>
                </a:r>
              </a:p>
              <a:p>
                <a:endParaRPr lang="en-US" altLang="en-US" sz="1500" b="1">
                  <a:solidFill>
                    <a:srgbClr val="FF0066"/>
                  </a:solidFill>
                  <a:latin typeface="Times New Roman" pitchFamily="18" charset="0"/>
                </a:endParaRPr>
              </a:p>
              <a:p>
                <a:endParaRPr lang="en-US" altLang="en-US" sz="1500" b="1">
                  <a:solidFill>
                    <a:srgbClr val="FF0066"/>
                  </a:solidFill>
                  <a:latin typeface="Calibri" pitchFamily="34" charset="0"/>
                </a:endParaRPr>
              </a:p>
            </p:txBody>
          </p:sp>
          <p:cxnSp>
            <p:nvCxnSpPr>
              <p:cNvPr id="58" name="AutoShape 16"/>
              <p:cNvCxnSpPr>
                <a:cxnSpLocks noChangeShapeType="1"/>
              </p:cNvCxnSpPr>
              <p:nvPr/>
            </p:nvCxnSpPr>
            <p:spPr bwMode="auto">
              <a:xfrm>
                <a:off x="9135032" y="3280942"/>
                <a:ext cx="0" cy="1066800"/>
              </a:xfrm>
              <a:prstGeom prst="straightConnector1">
                <a:avLst/>
              </a:prstGeom>
              <a:noFill/>
              <a:ln w="50800">
                <a:solidFill>
                  <a:srgbClr val="000000"/>
                </a:solidFill>
                <a:round/>
                <a:headEnd type="triangle" w="med" len="med"/>
                <a:tailEnd type="triangle" w="med" len="med"/>
              </a:ln>
            </p:spPr>
          </p:cxnSp>
          <p:cxnSp>
            <p:nvCxnSpPr>
              <p:cNvPr id="60" name="AutoShape 3"/>
              <p:cNvCxnSpPr>
                <a:cxnSpLocks noChangeShapeType="1"/>
              </p:cNvCxnSpPr>
              <p:nvPr/>
            </p:nvCxnSpPr>
            <p:spPr bwMode="auto">
              <a:xfrm>
                <a:off x="6468032" y="4347742"/>
                <a:ext cx="3962400" cy="0"/>
              </a:xfrm>
              <a:prstGeom prst="straightConnector1">
                <a:avLst/>
              </a:prstGeom>
              <a:noFill/>
              <a:ln w="50800">
                <a:solidFill>
                  <a:srgbClr val="000099"/>
                </a:solidFill>
                <a:round/>
                <a:headEnd/>
                <a:tailEnd/>
              </a:ln>
            </p:spPr>
          </p:cxnSp>
          <p:cxnSp>
            <p:nvCxnSpPr>
              <p:cNvPr id="61" name="AutoShape 8"/>
              <p:cNvCxnSpPr>
                <a:cxnSpLocks noChangeShapeType="1"/>
              </p:cNvCxnSpPr>
              <p:nvPr/>
            </p:nvCxnSpPr>
            <p:spPr bwMode="auto">
              <a:xfrm>
                <a:off x="6468032" y="3303167"/>
                <a:ext cx="0" cy="1044575"/>
              </a:xfrm>
              <a:prstGeom prst="straightConnector1">
                <a:avLst/>
              </a:prstGeom>
              <a:noFill/>
              <a:ln w="50800">
                <a:solidFill>
                  <a:srgbClr val="000099"/>
                </a:solidFill>
                <a:round/>
                <a:headEnd/>
                <a:tailEnd/>
              </a:ln>
            </p:spPr>
          </p:cxnSp>
          <p:cxnSp>
            <p:nvCxnSpPr>
              <p:cNvPr id="62" name="AutoShape 3"/>
              <p:cNvCxnSpPr>
                <a:cxnSpLocks noChangeShapeType="1"/>
              </p:cNvCxnSpPr>
              <p:nvPr/>
            </p:nvCxnSpPr>
            <p:spPr bwMode="auto">
              <a:xfrm>
                <a:off x="6468032" y="3280942"/>
                <a:ext cx="3962400" cy="0"/>
              </a:xfrm>
              <a:prstGeom prst="straightConnector1">
                <a:avLst/>
              </a:prstGeom>
              <a:noFill/>
              <a:ln w="50800">
                <a:solidFill>
                  <a:srgbClr val="000099"/>
                </a:solidFill>
                <a:round/>
                <a:headEnd/>
                <a:tailEnd/>
              </a:ln>
            </p:spPr>
          </p:cxnSp>
          <p:cxnSp>
            <p:nvCxnSpPr>
              <p:cNvPr id="64" name="AutoShape 16"/>
              <p:cNvCxnSpPr>
                <a:cxnSpLocks noChangeShapeType="1"/>
              </p:cNvCxnSpPr>
              <p:nvPr/>
            </p:nvCxnSpPr>
            <p:spPr bwMode="auto">
              <a:xfrm>
                <a:off x="10430432" y="3204742"/>
                <a:ext cx="0" cy="1143000"/>
              </a:xfrm>
              <a:prstGeom prst="straightConnector1">
                <a:avLst/>
              </a:prstGeom>
              <a:noFill/>
              <a:ln w="50800">
                <a:solidFill>
                  <a:srgbClr val="000000"/>
                </a:solidFill>
                <a:round/>
                <a:headEnd type="triangle" w="med" len="med"/>
                <a:tailEnd type="triangle" w="med" len="med"/>
              </a:ln>
            </p:spPr>
          </p:cxnSp>
          <p:cxnSp>
            <p:nvCxnSpPr>
              <p:cNvPr id="65" name="AutoShape 21"/>
              <p:cNvCxnSpPr>
                <a:cxnSpLocks noChangeShapeType="1"/>
              </p:cNvCxnSpPr>
              <p:nvPr/>
            </p:nvCxnSpPr>
            <p:spPr bwMode="auto">
              <a:xfrm>
                <a:off x="10430432" y="2836413"/>
                <a:ext cx="0" cy="304800"/>
              </a:xfrm>
              <a:prstGeom prst="straightConnector1">
                <a:avLst/>
              </a:prstGeom>
              <a:noFill/>
              <a:ln w="50800">
                <a:solidFill>
                  <a:srgbClr val="000000"/>
                </a:solidFill>
                <a:round/>
                <a:headEnd/>
                <a:tailEnd type="triangle" w="med" len="med"/>
              </a:ln>
            </p:spPr>
          </p:cxnSp>
          <p:cxnSp>
            <p:nvCxnSpPr>
              <p:cNvPr id="66" name="AutoShape 3"/>
              <p:cNvCxnSpPr>
                <a:cxnSpLocks noChangeShapeType="1"/>
              </p:cNvCxnSpPr>
              <p:nvPr/>
            </p:nvCxnSpPr>
            <p:spPr bwMode="auto">
              <a:xfrm flipV="1">
                <a:off x="6126390" y="3776242"/>
                <a:ext cx="341642" cy="8093"/>
              </a:xfrm>
              <a:prstGeom prst="straightConnector1">
                <a:avLst/>
              </a:prstGeom>
              <a:noFill/>
              <a:ln w="50800">
                <a:solidFill>
                  <a:srgbClr val="000099"/>
                </a:solidFill>
                <a:round/>
                <a:headEnd/>
                <a:tailEnd/>
              </a:ln>
            </p:spPr>
          </p:cxnSp>
          <p:sp>
            <p:nvSpPr>
              <p:cNvPr id="68" name="Right Arrow 67"/>
              <p:cNvSpPr/>
              <p:nvPr/>
            </p:nvSpPr>
            <p:spPr>
              <a:xfrm>
                <a:off x="4880680" y="3741126"/>
                <a:ext cx="562149" cy="113422"/>
              </a:xfrm>
              <a:prstGeom prst="rightArrow">
                <a:avLst/>
              </a:prstGeom>
              <a:solidFill>
                <a:srgbClr val="00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68580" tIns="34290" rIns="68580" bIns="34290" anchor="ctr"/>
              <a:lstStyle/>
              <a:p>
                <a:pPr>
                  <a:defRPr/>
                </a:pPr>
                <a:endParaRPr lang="en-US" sz="1350"/>
              </a:p>
            </p:txBody>
          </p:sp>
          <p:sp>
            <p:nvSpPr>
              <p:cNvPr id="69" name="Right Arrow 68"/>
              <p:cNvSpPr/>
              <p:nvPr/>
            </p:nvSpPr>
            <p:spPr>
              <a:xfrm rot="5400000">
                <a:off x="4379867" y="3199097"/>
                <a:ext cx="269378" cy="105791"/>
              </a:xfrm>
              <a:prstGeom prst="rightArrow">
                <a:avLst/>
              </a:prstGeom>
              <a:solidFill>
                <a:srgbClr val="00006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68580" tIns="34290" rIns="68580" bIns="34290" anchor="ctr"/>
              <a:lstStyle/>
              <a:p>
                <a:pPr>
                  <a:defRPr/>
                </a:pPr>
                <a:endParaRPr lang="en-US" sz="1350"/>
              </a:p>
            </p:txBody>
          </p:sp>
          <p:sp>
            <p:nvSpPr>
              <p:cNvPr id="70" name="Text Box 8"/>
              <p:cNvSpPr txBox="1">
                <a:spLocks noChangeArrowheads="1"/>
              </p:cNvSpPr>
              <p:nvPr/>
            </p:nvSpPr>
            <p:spPr bwMode="auto">
              <a:xfrm>
                <a:off x="2169501" y="3755530"/>
                <a:ext cx="738473" cy="2944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Fat pad</a:t>
                </a:r>
              </a:p>
            </p:txBody>
          </p:sp>
          <p:cxnSp>
            <p:nvCxnSpPr>
              <p:cNvPr id="71" name="Straight Arrow Connector 70"/>
              <p:cNvCxnSpPr/>
              <p:nvPr/>
            </p:nvCxnSpPr>
            <p:spPr>
              <a:xfrm flipH="1">
                <a:off x="2779361" y="3905183"/>
                <a:ext cx="365086" cy="0"/>
              </a:xfrm>
              <a:prstGeom prst="straightConnector1">
                <a:avLst/>
              </a:prstGeom>
              <a:ln>
                <a:solidFill>
                  <a:srgbClr val="00206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/>
              <p:cNvCxnSpPr/>
              <p:nvPr/>
            </p:nvCxnSpPr>
            <p:spPr>
              <a:xfrm flipV="1">
                <a:off x="3229496" y="2890459"/>
                <a:ext cx="16595" cy="334190"/>
              </a:xfrm>
              <a:prstGeom prst="straightConnector1">
                <a:avLst/>
              </a:prstGeom>
              <a:ln>
                <a:solidFill>
                  <a:srgbClr val="00206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 Box 8"/>
              <p:cNvSpPr txBox="1">
                <a:spLocks noChangeArrowheads="1"/>
              </p:cNvSpPr>
              <p:nvPr/>
            </p:nvSpPr>
            <p:spPr bwMode="auto">
              <a:xfrm>
                <a:off x="2684970" y="2617018"/>
                <a:ext cx="1248628" cy="2944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900" b="1">
                    <a:latin typeface="Times New Roman" pitchFamily="18" charset="0"/>
                    <a:cs typeface="Times New Roman" pitchFamily="18" charset="0"/>
                  </a:rPr>
                  <a:t>Epithelial ducts</a:t>
                </a:r>
              </a:p>
            </p:txBody>
          </p:sp>
          <p:sp>
            <p:nvSpPr>
              <p:cNvPr id="74" name="Text Box 8"/>
              <p:cNvSpPr txBox="1">
                <a:spLocks noChangeArrowheads="1"/>
              </p:cNvSpPr>
              <p:nvPr/>
            </p:nvSpPr>
            <p:spPr bwMode="auto">
              <a:xfrm>
                <a:off x="7944504" y="4391453"/>
                <a:ext cx="1671920" cy="3926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400" b="1">
                    <a:solidFill>
                      <a:srgbClr val="000000"/>
                    </a:solidFill>
                    <a:cs typeface="Times New Roman" pitchFamily="18" charset="0"/>
                  </a:rPr>
                  <a:t>           29 WK</a:t>
                </a:r>
                <a:endParaRPr lang="en-US" altLang="en-US" sz="14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" name="Text Box 8"/>
              <p:cNvSpPr txBox="1">
                <a:spLocks noChangeArrowheads="1"/>
              </p:cNvSpPr>
              <p:nvPr/>
            </p:nvSpPr>
            <p:spPr bwMode="auto">
              <a:xfrm>
                <a:off x="9505368" y="4342148"/>
                <a:ext cx="2002866" cy="6675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400" b="1" dirty="0">
                    <a:solidFill>
                      <a:srgbClr val="000000"/>
                    </a:solidFill>
                    <a:cs typeface="Times New Roman" pitchFamily="18" charset="0"/>
                  </a:rPr>
                  <a:t>           </a:t>
                </a:r>
                <a:r>
                  <a:rPr lang="en-US" altLang="en-US" sz="1400" b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33 or 37 </a:t>
                </a:r>
                <a:r>
                  <a:rPr lang="en-US" altLang="en-US" sz="1400" b="1" dirty="0">
                    <a:solidFill>
                      <a:srgbClr val="000000"/>
                    </a:solidFill>
                    <a:cs typeface="Times New Roman" pitchFamily="18" charset="0"/>
                  </a:rPr>
                  <a:t>WK</a:t>
                </a:r>
              </a:p>
              <a:p>
                <a:r>
                  <a:rPr lang="en-US" altLang="en-US" sz="1400" b="1" dirty="0">
                    <a:solidFill>
                      <a:srgbClr val="000000"/>
                    </a:solidFill>
                    <a:cs typeface="Times New Roman" pitchFamily="18" charset="0"/>
                  </a:rPr>
                  <a:t>                 </a:t>
                </a:r>
                <a:endParaRPr lang="en-US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8641480" y="2203848"/>
                <a:ext cx="1985156" cy="6481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en-US" sz="1350" b="1" dirty="0">
                    <a:solidFill>
                      <a:srgbClr val="FF0000"/>
                    </a:solidFill>
                    <a:latin typeface="Times New Roman" pitchFamily="18" charset="0"/>
                  </a:rPr>
                  <a:t>Treatment with </a:t>
                </a:r>
              </a:p>
              <a:p>
                <a:pPr>
                  <a:defRPr/>
                </a:pPr>
                <a:r>
                  <a:rPr lang="en-US" sz="1350" b="1" dirty="0">
                    <a:solidFill>
                      <a:srgbClr val="FF0000"/>
                    </a:solidFill>
                    <a:latin typeface="Times New Roman" pitchFamily="18" charset="0"/>
                  </a:rPr>
                  <a:t>E2 (100µg) for 8 h</a:t>
                </a: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8506647" y="3400859"/>
                <a:ext cx="1387741" cy="648128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sz="1350" b="1" dirty="0">
                    <a:solidFill>
                      <a:srgbClr val="003300"/>
                    </a:solidFill>
                    <a:latin typeface="Times New Roman" pitchFamily="18" charset="0"/>
                  </a:rPr>
                  <a:t>Removal of </a:t>
                </a:r>
              </a:p>
              <a:p>
                <a:pPr>
                  <a:defRPr/>
                </a:pPr>
                <a:r>
                  <a:rPr lang="en-US" sz="1350" b="1" dirty="0">
                    <a:solidFill>
                      <a:srgbClr val="003300"/>
                    </a:solidFill>
                    <a:latin typeface="Times New Roman" pitchFamily="18" charset="0"/>
                  </a:rPr>
                  <a:t> Tamoxifen</a:t>
                </a:r>
                <a:endParaRPr lang="en-US" sz="1350" b="1" dirty="0">
                  <a:solidFill>
                    <a:srgbClr val="003300"/>
                  </a:solidFill>
                  <a:latin typeface="Calibri" pitchFamily="34" charset="0"/>
                </a:endParaRPr>
              </a:p>
            </p:txBody>
          </p:sp>
        </p:grpSp>
        <p:pic>
          <p:nvPicPr>
            <p:cNvPr id="33" name="Picture 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384396" y="3962400"/>
              <a:ext cx="7620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4" name="Picture 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514600" y="3962400"/>
              <a:ext cx="7620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5" name="Picture 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505200" y="3962400"/>
              <a:ext cx="7620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7" name="Picture 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438400" y="2057400"/>
              <a:ext cx="7620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8" name="Text Box 8"/>
            <p:cNvSpPr txBox="1">
              <a:spLocks noChangeArrowheads="1"/>
            </p:cNvSpPr>
            <p:nvPr/>
          </p:nvSpPr>
          <p:spPr bwMode="auto">
            <a:xfrm>
              <a:off x="2469452" y="2057400"/>
              <a:ext cx="1264348" cy="4624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/>
            <a:lstStyle/>
            <a:p>
              <a:r>
                <a:rPr lang="en-US" altLang="en-US" sz="800" b="1">
                  <a:solidFill>
                    <a:srgbClr val="000000"/>
                  </a:solidFill>
                  <a:cs typeface="Times New Roman" pitchFamily="18" charset="0"/>
                </a:rPr>
                <a:t>8 WK p53 null  Balb/c</a:t>
              </a:r>
              <a:endParaRPr lang="en-US" altLang="en-US" sz="800" b="1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en-US" altLang="en-US" sz="800" b="1">
                  <a:solidFill>
                    <a:srgbClr val="000000"/>
                  </a:solidFill>
                  <a:cs typeface="Times New Roman" pitchFamily="18" charset="0"/>
                </a:rPr>
                <a:t>Donor gland</a:t>
              </a:r>
              <a:endParaRPr lang="en-US" altLang="en-US" sz="8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 Box 8"/>
            <p:cNvSpPr txBox="1">
              <a:spLocks noChangeArrowheads="1"/>
            </p:cNvSpPr>
            <p:nvPr/>
          </p:nvSpPr>
          <p:spPr bwMode="auto">
            <a:xfrm>
              <a:off x="1371600" y="4006334"/>
              <a:ext cx="96869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en-US" sz="800" b="1">
                  <a:solidFill>
                    <a:srgbClr val="000000"/>
                  </a:solidFill>
                  <a:cs typeface="Times New Roman" pitchFamily="18" charset="0"/>
                </a:rPr>
                <a:t>3 WK WT Balb/c</a:t>
              </a:r>
              <a:endParaRPr lang="en-US" altLang="en-US" sz="8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 Box 8"/>
            <p:cNvSpPr txBox="1">
              <a:spLocks noChangeArrowheads="1"/>
            </p:cNvSpPr>
            <p:nvPr/>
          </p:nvSpPr>
          <p:spPr bwMode="auto">
            <a:xfrm>
              <a:off x="2510903" y="4038600"/>
              <a:ext cx="96869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en-US" sz="800" b="1">
                  <a:solidFill>
                    <a:srgbClr val="000000"/>
                  </a:solidFill>
                  <a:cs typeface="Times New Roman" pitchFamily="18" charset="0"/>
                </a:rPr>
                <a:t>8 WK WT Balb/c</a:t>
              </a:r>
              <a:endParaRPr lang="en-US" altLang="en-US" sz="8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 Box 8"/>
            <p:cNvSpPr txBox="1">
              <a:spLocks noChangeArrowheads="1"/>
            </p:cNvSpPr>
            <p:nvPr/>
          </p:nvSpPr>
          <p:spPr bwMode="auto">
            <a:xfrm>
              <a:off x="3505200" y="4038600"/>
              <a:ext cx="102650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en-US" sz="800" b="1">
                  <a:solidFill>
                    <a:srgbClr val="000000"/>
                  </a:solidFill>
                  <a:cs typeface="Times New Roman" pitchFamily="18" charset="0"/>
                </a:rPr>
                <a:t>16 WK WT Balb/c</a:t>
              </a:r>
              <a:endParaRPr lang="en-US" altLang="en-US" sz="800" b="1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95" name="TextBox 94"/>
          <p:cNvSpPr txBox="1"/>
          <p:nvPr/>
        </p:nvSpPr>
        <p:spPr>
          <a:xfrm>
            <a:off x="914400" y="62126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762000" y="290726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3" descr="R:\Conneely_Orla\Murugesan\P53 null mammary gland project\4 WeeksTAM Withdraw\Whole Mount 1\Whole Mount Jan 2016\TAM3763 5X.tif 2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0" y="4953000"/>
            <a:ext cx="1832575" cy="13704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R:\Conneely_Orla\Murugesan\P53 null mammary gland project\4 WeeksTAM Withdraw\Whole Mount 1\Whole Mount Jan 2016\3762 TAM 5X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0" y="3505200"/>
            <a:ext cx="1826859" cy="13661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8" name="Straight Connector 107"/>
          <p:cNvCxnSpPr/>
          <p:nvPr/>
        </p:nvCxnSpPr>
        <p:spPr>
          <a:xfrm flipV="1">
            <a:off x="914400" y="3505200"/>
            <a:ext cx="1447800" cy="3048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>
            <a:off x="914400" y="4114800"/>
            <a:ext cx="1447800" cy="6858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 flipV="1">
            <a:off x="1295400" y="5029200"/>
            <a:ext cx="1066800" cy="762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1295400" y="5410200"/>
            <a:ext cx="1066800" cy="609600"/>
          </a:xfrm>
          <a:prstGeom prst="line">
            <a:avLst/>
          </a:prstGeom>
          <a:ln w="15875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8007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88</TotalTime>
  <Words>65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laniappan, Murugesan</dc:creator>
  <cp:lastModifiedBy>Palaniappan, Murugesan</cp:lastModifiedBy>
  <cp:revision>125</cp:revision>
  <cp:lastPrinted>2017-10-11T21:52:18Z</cp:lastPrinted>
  <dcterms:created xsi:type="dcterms:W3CDTF">2015-10-08T14:08:51Z</dcterms:created>
  <dcterms:modified xsi:type="dcterms:W3CDTF">2018-03-20T18:47:03Z</dcterms:modified>
</cp:coreProperties>
</file>